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3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 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3B9353-BDE5-4CF5-8821-56669BC7D997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Slayt Resmi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r-TR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6" name="Alt 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171AA4-8674-4A21-BDCD-5FD41D0642F8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7984609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ayt Resmi Yer Tutucus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 Yer Tutucusu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tr-TR" dirty="0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171AA4-8674-4A21-BDCD-5FD41D0642F8}" type="slidenum">
              <a:rPr lang="tr-TR" smtClean="0"/>
              <a:t>1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7669732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7D132F7C-B777-BB21-B005-35318844F2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114A8DFC-009D-DA66-6BDB-0721F28F62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2E135DAF-949E-15C0-F894-CDF093B69E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BF06761-5BB8-0BD1-C837-363BDF296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8349E07-C516-D713-C16C-BC08DF600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55874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767A9C4-F583-C778-7AC6-D2AFFF830F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D65FAE13-410C-2BA5-0003-E822240451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0041736B-E7D0-89B7-C65F-47B53145B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A0098199-7D1B-DAB3-068C-1B4E1F07C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0CA734AC-8B1A-7516-10FB-9B0C3BCFE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51440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192DBABF-AFD5-8496-BFF1-08DC49C83B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24E44FFA-DEB6-E6ED-B28B-5AD9929137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8CB2998-5D8A-5269-9F2B-5631967D5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7C1D49E3-C1CF-76B4-8124-17CFC47F4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178B224-EC80-ED2D-1211-60EC19749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20211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609682C-400E-0F73-D43C-35384E7F2C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B33B5637-56B3-8B3B-2E32-1BFC718B20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CDC844F-F2BB-0A4F-C5F9-947A58068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CAD67963-A2E6-0704-879F-4D361F656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ADE2AAA5-AC87-D341-A13D-5AEEB169B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615050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117B43D-7C40-CCB7-F6C5-D277E9B831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AE1C965F-23B0-E0CD-74CC-86905C3768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63EF9F49-E54D-AF08-D9C3-9D66FD679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D6488E1F-7614-1A48-26CF-456121911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76AF750E-AC8A-952D-9044-37CB12C5F1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0930389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D3EE11B-D41B-403C-31C5-4B3450CD8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2C55A8CE-C027-6979-A760-EE537322AD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87B55CD1-3A4F-3E98-4A7D-86218F8258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EFA89A02-B5E5-5650-FE40-9C2BD5496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2778EF84-78DD-BE10-8132-57E007979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0E0116AF-838C-A49A-F4F7-618679089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879004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4F9D254F-B329-FF1C-B2DB-214E23F849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7CA43C0B-6158-3B8C-72E1-DC26E62BF9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BDBF2030-A29A-EC3E-0BA3-E187A7754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BC89967A-2E53-DE38-30E5-B6CD00D606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694D1656-4E50-015A-CEAE-0515038A7B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7BE12030-3BA6-1831-8C28-71985A532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8CD71A76-F2E9-DEA9-788D-72D750899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FC09D232-0415-6237-5A04-B0317F6530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853990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B059E04-A916-A31A-2C8C-4B29B571C2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A80369B7-3CF1-4036-E03B-8D7A5D1E2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592010EB-2230-FB37-F7C0-4BCF1708B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DBB51F7E-18EE-2557-125B-325C799AB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28058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3A62B955-00D4-DD94-37CB-60F82275BD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AE6CEE18-B1AA-1FF2-1FA6-B17CE3931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1AE3496F-424B-222B-CAED-76356F832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235318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0F65AD6-F80B-7CD0-ED22-878F4CD3D2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47F943D3-C431-0DF4-59B9-249D8C5446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B0B47AB3-2817-C4C5-D213-155DC85C4E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600AE6BF-EF63-ECA4-A5A6-1994EEE25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48012D6B-02D8-7297-2B41-BFF4D49F1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B3D8843-AC66-524B-BE18-AD6F84392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384422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8CB6D970-3FEA-DB2F-D893-C29BA1ADD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D2F81C3F-95E9-2A30-E567-FA63B19177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4D9F7ED2-BE44-DF25-6891-BB21A6B226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6B73AA93-3EA3-53EA-480E-7242EF07E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1A3CF563-FDCB-50DE-6ACE-053E5BFF7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3CC36791-1177-79E8-9AB1-D4B2A4640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14016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EEDC6E04-ABB5-3CBB-7A51-B1E836940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DF20BB4A-D35C-B183-445B-D6F7A57AEF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879E1CE8-B9E2-D00C-D821-F9AB4A7D42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3A9-AC4E-4118-806B-48569579EDF9}" type="datetimeFigureOut">
              <a:rPr lang="tr-TR" smtClean="0"/>
              <a:t>7.09.2023</a:t>
            </a:fld>
            <a:endParaRPr lang="tr-TR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9F33E05E-FEF1-4908-2B3F-D194E017D5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B6E54D82-4F65-DB83-85B2-F83BFB92E5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85051-4B96-4F0A-B32A-897CB386446B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495550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143.png">
            <a:extLst>
              <a:ext uri="{FF2B5EF4-FFF2-40B4-BE49-F238E27FC236}">
                <a16:creationId xmlns:a16="http://schemas.microsoft.com/office/drawing/2014/main" id="{CDE4D026-57B4-6573-5CCB-98B76203D747}"/>
              </a:ext>
            </a:extLst>
          </p:cNvPr>
          <p:cNvPicPr/>
          <p:nvPr/>
        </p:nvPicPr>
        <p:blipFill rotWithShape="1">
          <a:blip r:embed="rId3"/>
          <a:srcRect l="9549" r="19881" b="4624"/>
          <a:stretch/>
        </p:blipFill>
        <p:spPr>
          <a:xfrm>
            <a:off x="2343150" y="398541"/>
            <a:ext cx="2943225" cy="6003765"/>
          </a:xfrm>
          <a:prstGeom prst="rect">
            <a:avLst/>
          </a:prstGeom>
          <a:ln/>
        </p:spPr>
      </p:pic>
      <p:pic>
        <p:nvPicPr>
          <p:cNvPr id="5" name="image141.png">
            <a:extLst>
              <a:ext uri="{FF2B5EF4-FFF2-40B4-BE49-F238E27FC236}">
                <a16:creationId xmlns:a16="http://schemas.microsoft.com/office/drawing/2014/main" id="{0BAA29F8-26A3-4C82-DFDD-EDBE0D625D05}"/>
              </a:ext>
            </a:extLst>
          </p:cNvPr>
          <p:cNvPicPr/>
          <p:nvPr/>
        </p:nvPicPr>
        <p:blipFill rotWithShape="1">
          <a:blip r:embed="rId4"/>
          <a:srcRect r="38511" b="3501"/>
          <a:stretch/>
        </p:blipFill>
        <p:spPr>
          <a:xfrm>
            <a:off x="5694679" y="427116"/>
            <a:ext cx="2943225" cy="6003765"/>
          </a:xfrm>
          <a:prstGeom prst="rect">
            <a:avLst/>
          </a:prstGeom>
          <a:ln/>
        </p:spPr>
      </p:pic>
      <p:sp>
        <p:nvSpPr>
          <p:cNvPr id="6" name="Metin kutusu 5">
            <a:extLst>
              <a:ext uri="{FF2B5EF4-FFF2-40B4-BE49-F238E27FC236}">
                <a16:creationId xmlns:a16="http://schemas.microsoft.com/office/drawing/2014/main" id="{238928DF-ACF4-BBF7-6671-1D1B5D2537D2}"/>
              </a:ext>
            </a:extLst>
          </p:cNvPr>
          <p:cNvSpPr txBox="1"/>
          <p:nvPr/>
        </p:nvSpPr>
        <p:spPr>
          <a:xfrm>
            <a:off x="1238528" y="1378325"/>
            <a:ext cx="141550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2</a:t>
            </a:r>
          </a:p>
        </p:txBody>
      </p:sp>
      <p:sp>
        <p:nvSpPr>
          <p:cNvPr id="7" name="Metin kutusu 6">
            <a:extLst>
              <a:ext uri="{FF2B5EF4-FFF2-40B4-BE49-F238E27FC236}">
                <a16:creationId xmlns:a16="http://schemas.microsoft.com/office/drawing/2014/main" id="{0D9B29F5-AF10-3910-8719-5DF5C28461FD}"/>
              </a:ext>
            </a:extLst>
          </p:cNvPr>
          <p:cNvSpPr txBox="1"/>
          <p:nvPr/>
        </p:nvSpPr>
        <p:spPr>
          <a:xfrm>
            <a:off x="1243014" y="526133"/>
            <a:ext cx="133171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1</a:t>
            </a:r>
          </a:p>
        </p:txBody>
      </p:sp>
      <p:sp>
        <p:nvSpPr>
          <p:cNvPr id="8" name="Metin kutusu 7">
            <a:extLst>
              <a:ext uri="{FF2B5EF4-FFF2-40B4-BE49-F238E27FC236}">
                <a16:creationId xmlns:a16="http://schemas.microsoft.com/office/drawing/2014/main" id="{96AEA2DD-22AA-B40D-20AD-1DAD29B9CF8F}"/>
              </a:ext>
            </a:extLst>
          </p:cNvPr>
          <p:cNvSpPr txBox="1"/>
          <p:nvPr/>
        </p:nvSpPr>
        <p:spPr>
          <a:xfrm>
            <a:off x="1243014" y="2230517"/>
            <a:ext cx="133171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3</a:t>
            </a:r>
          </a:p>
        </p:txBody>
      </p:sp>
      <p:sp>
        <p:nvSpPr>
          <p:cNvPr id="9" name="Metin kutusu 8">
            <a:extLst>
              <a:ext uri="{FF2B5EF4-FFF2-40B4-BE49-F238E27FC236}">
                <a16:creationId xmlns:a16="http://schemas.microsoft.com/office/drawing/2014/main" id="{D0C893E0-A58E-985C-4D8B-1F2CA45ECB33}"/>
              </a:ext>
            </a:extLst>
          </p:cNvPr>
          <p:cNvSpPr txBox="1"/>
          <p:nvPr/>
        </p:nvSpPr>
        <p:spPr>
          <a:xfrm>
            <a:off x="1243014" y="3082709"/>
            <a:ext cx="133171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4</a:t>
            </a:r>
          </a:p>
        </p:txBody>
      </p:sp>
      <p:sp>
        <p:nvSpPr>
          <p:cNvPr id="10" name="Metin kutusu 9">
            <a:extLst>
              <a:ext uri="{FF2B5EF4-FFF2-40B4-BE49-F238E27FC236}">
                <a16:creationId xmlns:a16="http://schemas.microsoft.com/office/drawing/2014/main" id="{2D853958-D7B1-EBF3-32A5-AC7B60CCEC2F}"/>
              </a:ext>
            </a:extLst>
          </p:cNvPr>
          <p:cNvSpPr txBox="1"/>
          <p:nvPr/>
        </p:nvSpPr>
        <p:spPr>
          <a:xfrm>
            <a:off x="1242354" y="3934901"/>
            <a:ext cx="1332985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5</a:t>
            </a:r>
          </a:p>
        </p:txBody>
      </p:sp>
      <p:sp>
        <p:nvSpPr>
          <p:cNvPr id="11" name="Metin kutusu 10">
            <a:extLst>
              <a:ext uri="{FF2B5EF4-FFF2-40B4-BE49-F238E27FC236}">
                <a16:creationId xmlns:a16="http://schemas.microsoft.com/office/drawing/2014/main" id="{763EAB64-80BF-4465-40DC-5F1FE786D54A}"/>
              </a:ext>
            </a:extLst>
          </p:cNvPr>
          <p:cNvSpPr txBox="1"/>
          <p:nvPr/>
        </p:nvSpPr>
        <p:spPr>
          <a:xfrm>
            <a:off x="1243014" y="4787093"/>
            <a:ext cx="133171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6</a:t>
            </a:r>
          </a:p>
        </p:txBody>
      </p:sp>
      <p:sp>
        <p:nvSpPr>
          <p:cNvPr id="12" name="Metin kutusu 11">
            <a:extLst>
              <a:ext uri="{FF2B5EF4-FFF2-40B4-BE49-F238E27FC236}">
                <a16:creationId xmlns:a16="http://schemas.microsoft.com/office/drawing/2014/main" id="{DD03810C-417C-00C5-97BA-FC5506070A77}"/>
              </a:ext>
            </a:extLst>
          </p:cNvPr>
          <p:cNvSpPr txBox="1"/>
          <p:nvPr/>
        </p:nvSpPr>
        <p:spPr>
          <a:xfrm>
            <a:off x="1243014" y="5639286"/>
            <a:ext cx="1331718" cy="56194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>
              <a:lnSpc>
                <a:spcPct val="200000"/>
              </a:lnSpc>
            </a:pPr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7</a:t>
            </a:r>
          </a:p>
        </p:txBody>
      </p:sp>
      <p:sp>
        <p:nvSpPr>
          <p:cNvPr id="13" name="Metin kutusu 12">
            <a:extLst>
              <a:ext uri="{FF2B5EF4-FFF2-40B4-BE49-F238E27FC236}">
                <a16:creationId xmlns:a16="http://schemas.microsoft.com/office/drawing/2014/main" id="{3D7DC23F-FA24-7296-F1E2-DBCA2072A53E}"/>
              </a:ext>
            </a:extLst>
          </p:cNvPr>
          <p:cNvSpPr txBox="1"/>
          <p:nvPr/>
        </p:nvSpPr>
        <p:spPr>
          <a:xfrm>
            <a:off x="2319673" y="10728"/>
            <a:ext cx="3375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rizontal(Maximum-Minimum)</a:t>
            </a:r>
          </a:p>
        </p:txBody>
      </p:sp>
      <p:sp>
        <p:nvSpPr>
          <p:cNvPr id="14" name="Metin kutusu 13">
            <a:extLst>
              <a:ext uri="{FF2B5EF4-FFF2-40B4-BE49-F238E27FC236}">
                <a16:creationId xmlns:a16="http://schemas.microsoft.com/office/drawing/2014/main" id="{729A6A55-6442-35F9-AA97-FADA6720D7D2}"/>
              </a:ext>
            </a:extLst>
          </p:cNvPr>
          <p:cNvSpPr txBox="1"/>
          <p:nvPr/>
        </p:nvSpPr>
        <p:spPr>
          <a:xfrm>
            <a:off x="5625462" y="-7753"/>
            <a:ext cx="3181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lique (Maximum-Minimum)</a:t>
            </a:r>
          </a:p>
        </p:txBody>
      </p:sp>
      <p:grpSp>
        <p:nvGrpSpPr>
          <p:cNvPr id="21" name="Grup 20">
            <a:extLst>
              <a:ext uri="{FF2B5EF4-FFF2-40B4-BE49-F238E27FC236}">
                <a16:creationId xmlns:a16="http://schemas.microsoft.com/office/drawing/2014/main" id="{A4E1B9CC-2B3D-FE4B-049F-D6A30B49E05E}"/>
              </a:ext>
            </a:extLst>
          </p:cNvPr>
          <p:cNvGrpSpPr/>
          <p:nvPr/>
        </p:nvGrpSpPr>
        <p:grpSpPr>
          <a:xfrm>
            <a:off x="9046208" y="1298518"/>
            <a:ext cx="2571191" cy="4260961"/>
            <a:chOff x="1286167" y="630260"/>
            <a:chExt cx="3031653" cy="5084468"/>
          </a:xfrm>
        </p:grpSpPr>
        <p:pic>
          <p:nvPicPr>
            <p:cNvPr id="22" name="Resim 21">
              <a:extLst>
                <a:ext uri="{FF2B5EF4-FFF2-40B4-BE49-F238E27FC236}">
                  <a16:creationId xmlns:a16="http://schemas.microsoft.com/office/drawing/2014/main" id="{CE463B86-E061-29DE-AA9F-C6FC52574F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890" t="70900" b="6708"/>
            <a:stretch/>
          </p:blipFill>
          <p:spPr>
            <a:xfrm>
              <a:off x="1966799" y="630260"/>
              <a:ext cx="1777033" cy="2193986"/>
            </a:xfrm>
            <a:prstGeom prst="rect">
              <a:avLst/>
            </a:prstGeom>
          </p:spPr>
        </p:pic>
        <p:grpSp>
          <p:nvGrpSpPr>
            <p:cNvPr id="23" name="Grup 22">
              <a:extLst>
                <a:ext uri="{FF2B5EF4-FFF2-40B4-BE49-F238E27FC236}">
                  <a16:creationId xmlns:a16="http://schemas.microsoft.com/office/drawing/2014/main" id="{61460B0D-2EB8-C2FF-ABA7-C4BF087C364A}"/>
                </a:ext>
              </a:extLst>
            </p:cNvPr>
            <p:cNvGrpSpPr/>
            <p:nvPr/>
          </p:nvGrpSpPr>
          <p:grpSpPr>
            <a:xfrm>
              <a:off x="2855316" y="2937662"/>
              <a:ext cx="1462504" cy="2777066"/>
              <a:chOff x="3196303" y="3002751"/>
              <a:chExt cx="1462504" cy="2777066"/>
            </a:xfrm>
          </p:grpSpPr>
          <p:pic>
            <p:nvPicPr>
              <p:cNvPr id="27" name="Resim 26">
                <a:extLst>
                  <a:ext uri="{FF2B5EF4-FFF2-40B4-BE49-F238E27FC236}">
                    <a16:creationId xmlns:a16="http://schemas.microsoft.com/office/drawing/2014/main" id="{0E888EED-DBF4-C601-F177-F2E629C2F5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0578" b="67754"/>
              <a:stretch/>
            </p:blipFill>
            <p:spPr>
              <a:xfrm>
                <a:off x="3196303" y="3002751"/>
                <a:ext cx="1462504" cy="277706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8" name="Metin kutusu 27">
                <a:extLst>
                  <a:ext uri="{FF2B5EF4-FFF2-40B4-BE49-F238E27FC236}">
                    <a16:creationId xmlns:a16="http://schemas.microsoft.com/office/drawing/2014/main" id="{5F68682E-1E10-CEBB-F909-4BED7B476F4C}"/>
                  </a:ext>
                </a:extLst>
              </p:cNvPr>
              <p:cNvSpPr txBox="1"/>
              <p:nvPr/>
            </p:nvSpPr>
            <p:spPr>
              <a:xfrm>
                <a:off x="4117451" y="5266810"/>
                <a:ext cx="382698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tr-TR" sz="2400" dirty="0"/>
                  <a:t>B</a:t>
                </a:r>
              </a:p>
            </p:txBody>
          </p:sp>
        </p:grpSp>
        <p:grpSp>
          <p:nvGrpSpPr>
            <p:cNvPr id="24" name="Grup 23">
              <a:extLst>
                <a:ext uri="{FF2B5EF4-FFF2-40B4-BE49-F238E27FC236}">
                  <a16:creationId xmlns:a16="http://schemas.microsoft.com/office/drawing/2014/main" id="{BA140422-42D8-7C92-E9BF-45310FE60022}"/>
                </a:ext>
              </a:extLst>
            </p:cNvPr>
            <p:cNvGrpSpPr/>
            <p:nvPr/>
          </p:nvGrpSpPr>
          <p:grpSpPr>
            <a:xfrm>
              <a:off x="1286167" y="2937662"/>
              <a:ext cx="1462504" cy="2777065"/>
              <a:chOff x="1286167" y="2937662"/>
              <a:chExt cx="1462504" cy="2777065"/>
            </a:xfrm>
          </p:grpSpPr>
          <p:pic>
            <p:nvPicPr>
              <p:cNvPr id="25" name="Resim 24">
                <a:extLst>
                  <a:ext uri="{FF2B5EF4-FFF2-40B4-BE49-F238E27FC236}">
                    <a16:creationId xmlns:a16="http://schemas.microsoft.com/office/drawing/2014/main" id="{F8612624-333E-5569-99B6-008C25327D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0610" b="67863"/>
              <a:stretch/>
            </p:blipFill>
            <p:spPr>
              <a:xfrm>
                <a:off x="1286167" y="2937662"/>
                <a:ext cx="1462504" cy="277706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6" name="Metin kutusu 25">
                <a:extLst>
                  <a:ext uri="{FF2B5EF4-FFF2-40B4-BE49-F238E27FC236}">
                    <a16:creationId xmlns:a16="http://schemas.microsoft.com/office/drawing/2014/main" id="{18E73541-9755-AD3F-C358-58E407024B06}"/>
                  </a:ext>
                </a:extLst>
              </p:cNvPr>
              <p:cNvSpPr txBox="1"/>
              <p:nvPr/>
            </p:nvSpPr>
            <p:spPr>
              <a:xfrm>
                <a:off x="2082678" y="5201722"/>
                <a:ext cx="355587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tr-TR" sz="2400" dirty="0"/>
                  <a:t>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22115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25</Words>
  <Application>Microsoft Office PowerPoint</Application>
  <PresentationFormat>Geniş ekran</PresentationFormat>
  <Paragraphs>12</Paragraphs>
  <Slides>1</Slides>
  <Notes>1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4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Beril Demircan</dc:creator>
  <cp:lastModifiedBy>Beril Demircan</cp:lastModifiedBy>
  <cp:revision>8</cp:revision>
  <dcterms:created xsi:type="dcterms:W3CDTF">2023-05-17T11:00:41Z</dcterms:created>
  <dcterms:modified xsi:type="dcterms:W3CDTF">2023-09-07T06:27:12Z</dcterms:modified>
</cp:coreProperties>
</file>